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97EC31-7720-83A7-4520-DB3414B3AC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8BB163-81EB-78C3-4ACE-1F40C0DE5F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05C389-B45B-FC64-FF89-691EEE8A7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3892D0-289B-8D2E-0917-100D0C2AA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4CE29-0E5E-4788-9F88-DDCE40BD5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479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4CA56A-42C5-0AB2-CF77-65777B1AF5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D54B49-AA7F-51DC-BF0A-95EDB1AA9B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7654B5-0FE0-4063-36FA-EF7E39701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EF155B-D38C-285C-B6F2-0B5833BB0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76AC4B-243C-959C-D003-B45B3B848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813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7873EA6-8280-7321-B37D-7976EEAE70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F15809-C39D-4C66-1803-681047C5DB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CA84A7-375C-1FF0-203C-2CB6270CB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CD5327-79FF-A682-BF66-A3FCD91E9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E63AF1-4D3E-5D12-15EA-823347BAC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477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34117F-B1B8-444F-0A98-5A2958DE1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001046-674D-EB59-9F06-05A37868F4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8FEB0-779C-90E0-BC4B-A753A33C1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2163E6-6406-1DBA-B478-2CFBB29268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673677-80C5-9EE8-D674-76345ACCD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281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66912D-94C6-D3C9-C22D-CBE1104A1E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6E4EDA-CBD5-5D1D-F8CF-67B06C2617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34E370-0813-9223-DBFD-CF52D6082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DA8961-8EBF-8204-D39E-34116378F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96A4D9-B0A0-13F4-9BD8-826BDAF27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027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5C1EC-AA0B-A07C-15AF-3CB1EED8E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AE33A3-7754-F719-9F6D-BE8969CFCB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8B356D-B731-7DC1-B319-22F8803997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D579BF-7891-1D7C-19E4-9748BC0C4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F589AC-C551-A61C-706E-B0D1D6439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D3CD07-8CD4-C58E-447C-4EDFD8902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058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3A8B0-F2AE-D0AB-4E52-05B7E4C37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CEF6D6-69F0-DF2A-259E-F0A7AAF8EC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0E31E7-95B8-FC95-3ABB-DAEFC17EC6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2C138C-921C-ADA9-5696-78353B3F53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4AD20E-DA43-C05E-3C96-6F8BA8C8C3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C3640F-ABDD-CE23-A19B-700716B74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6E507A-CC4E-E051-F1A4-5247CA1E4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BFA1FA-9571-3944-F462-1D9C7AF7D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753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41349C-962C-77FF-2008-2ADBCA68B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21F54C-F2BF-D3B0-6391-02BE19DEB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E17536-8846-0F3D-8438-39774B5C7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313A8A-62F5-1A97-B237-9CABE994A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608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098ABE-F3F5-BAE9-4FF6-F3A44F3F4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3C4CBF-A80B-2E9F-8C50-DD79E663E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C54A6C-414A-2A66-39B8-19B3AAC00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424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A7972-0AA6-1DA2-0127-616DF787FF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81B3EF-473F-2A37-BDF7-E7ED7B0EDF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0A5454-FD83-6A9D-542D-364AC1579D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AFD0A8-4CE1-5781-FDBB-1B4E523F4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DC00A4-3710-B213-5720-E3F3742D8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B79EB2-2513-5464-8493-D79787C4D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441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2C9375-6F01-DA78-EC66-264EAFE0A6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84D8A6-07F3-062A-F41D-F8F3995964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2E8CB3-04DD-84E5-0871-FD46F2C593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516AD4-AFBC-5EA5-7BF4-AA0841565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B44276-9BCE-BE80-A3AC-E4F4EFEDF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3361A4-24C5-9AB6-C322-98343F676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751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D14ED4-9B4C-46E9-9304-FAFD64549E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A015B3-11F8-2428-8C67-2244364F29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77277-D09D-9F91-CB35-01963C059E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8D8C7A-160E-4932-8A9F-2B9FB24B254E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681EEE-CCF3-B5A6-60DA-E864AEA9D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48F964-53D0-38ED-A42F-8196345B8F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5319EE-0488-43A7-A809-7DCBDAB07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778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B1076C7-7CDD-85E8-15C9-18A1A43D29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1894" y="0"/>
            <a:ext cx="474821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5068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BC40410-8328-9C5D-D8B2-B9B413D1692C}"/>
              </a:ext>
            </a:extLst>
          </p:cNvPr>
          <p:cNvSpPr txBox="1"/>
          <p:nvPr/>
        </p:nvSpPr>
        <p:spPr>
          <a:xfrm>
            <a:off x="3048000" y="2116493"/>
            <a:ext cx="6096000" cy="26250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Aft>
                <a:spcPts val="800"/>
              </a:spcAft>
            </a:pPr>
            <a:r>
              <a:rPr lang="en-GB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3: 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dditional analysis of single-nuclear RNA-sequencing data. (A) UMAP of single-nuclear RNA-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eq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lusters. (B) UMAP showing major cell types identified. (C) Violin plot of expression of major prostate cancer cell type markers</a:t>
            </a:r>
            <a:r>
              <a:rPr lang="en-GB" sz="1800" kern="100" baseline="300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4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cross clusters, used for cell type annotations (D) Distribution of major cell types in samples across 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laparib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laparib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+ 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egarelix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ment conditions.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3020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egmann, Bill</dc:creator>
  <cp:lastModifiedBy>Siegmann, Bill</cp:lastModifiedBy>
  <cp:revision>1</cp:revision>
  <dcterms:created xsi:type="dcterms:W3CDTF">2025-04-08T14:50:55Z</dcterms:created>
  <dcterms:modified xsi:type="dcterms:W3CDTF">2025-04-08T14:51:37Z</dcterms:modified>
</cp:coreProperties>
</file>